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331C436-3043-56DF-421C-521451599D42}" v="36" dt="2022-03-24T14:27:00.1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2" autoAdjust="0"/>
    <p:restoredTop sz="94660"/>
  </p:normalViewPr>
  <p:slideViewPr>
    <p:cSldViewPr snapToGrid="0">
      <p:cViewPr varScale="1">
        <p:scale>
          <a:sx n="64" d="100"/>
          <a:sy n="64" d="100"/>
        </p:scale>
        <p:origin x="5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nnifer Kerr" userId="S::jkerr@ues.com::a20994fc-93b6-4c5a-817c-7226315ee8fd" providerId="AD" clId="Web-{8331C436-3043-56DF-421C-521451599D42}"/>
    <pc:docChg chg="modSld">
      <pc:chgData name="Jennifer Kerr" userId="S::jkerr@ues.com::a20994fc-93b6-4c5a-817c-7226315ee8fd" providerId="AD" clId="Web-{8331C436-3043-56DF-421C-521451599D42}" dt="2022-03-24T14:26:53.492" v="15"/>
      <pc:docMkLst>
        <pc:docMk/>
      </pc:docMkLst>
      <pc:sldChg chg="modSp">
        <pc:chgData name="Jennifer Kerr" userId="S::jkerr@ues.com::a20994fc-93b6-4c5a-817c-7226315ee8fd" providerId="AD" clId="Web-{8331C436-3043-56DF-421C-521451599D42}" dt="2022-03-24T14:26:53.492" v="15"/>
        <pc:sldMkLst>
          <pc:docMk/>
          <pc:sldMk cId="3195115491" sldId="256"/>
        </pc:sldMkLst>
        <pc:graphicFrameChg chg="mod modGraphic">
          <ac:chgData name="Jennifer Kerr" userId="S::jkerr@ues.com::a20994fc-93b6-4c5a-817c-7226315ee8fd" providerId="AD" clId="Web-{8331C436-3043-56DF-421C-521451599D42}" dt="2022-03-24T14:26:53.492" v="15"/>
          <ac:graphicFrameMkLst>
            <pc:docMk/>
            <pc:sldMk cId="3195115491" sldId="256"/>
            <ac:graphicFrameMk id="4" creationId="{3DF09B84-6803-4691-9543-74FDB59827B1}"/>
          </ac:graphicFrameMkLst>
        </pc:graphicFrameChg>
      </pc:sldChg>
    </pc:docChg>
  </pc:docChgLst>
  <pc:docChgLst>
    <pc:chgData name="Jennifer Kerr" userId="a20994fc-93b6-4c5a-817c-7226315ee8fd" providerId="ADAL" clId="{78E442CA-8507-43C6-9448-8B22650F2910}"/>
    <pc:docChg chg="modSld">
      <pc:chgData name="Jennifer Kerr" userId="a20994fc-93b6-4c5a-817c-7226315ee8fd" providerId="ADAL" clId="{78E442CA-8507-43C6-9448-8B22650F2910}" dt="2022-03-24T14:18:12.163" v="2" actId="20577"/>
      <pc:docMkLst>
        <pc:docMk/>
      </pc:docMkLst>
      <pc:sldChg chg="modSp mod">
        <pc:chgData name="Jennifer Kerr" userId="a20994fc-93b6-4c5a-817c-7226315ee8fd" providerId="ADAL" clId="{78E442CA-8507-43C6-9448-8B22650F2910}" dt="2022-03-24T14:18:12.163" v="2" actId="20577"/>
        <pc:sldMkLst>
          <pc:docMk/>
          <pc:sldMk cId="3195115491" sldId="256"/>
        </pc:sldMkLst>
        <pc:graphicFrameChg chg="modGraphic">
          <ac:chgData name="Jennifer Kerr" userId="a20994fc-93b6-4c5a-817c-7226315ee8fd" providerId="ADAL" clId="{78E442CA-8507-43C6-9448-8B22650F2910}" dt="2022-03-24T14:18:12.163" v="2" actId="20577"/>
          <ac:graphicFrameMkLst>
            <pc:docMk/>
            <pc:sldMk cId="3195115491" sldId="256"/>
            <ac:graphicFrameMk id="4" creationId="{3DF09B84-6803-4691-9543-74FDB59827B1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B4A2CB-EE47-46BF-B596-EAF1DF0836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2DAA3F-68C9-4BA1-BAF8-D51B58DCD4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0FC034-5EBD-4927-B44A-7E6B10225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DEF97A-7A61-4844-921D-D4C1A57458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6B61B6-5E04-4579-9B4C-3FC82BBBD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103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9956D1-CEAE-4A45-9F62-8B14DD6D45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1B02C7-0571-4D60-9DFE-E78F2751FF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EF4245-E7B6-43E5-9CE4-946CCF427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8BCACE-86C2-472D-8505-14343C502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32766B-1B35-46CD-9B2F-CDA345465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747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944DB15-BD41-4DB0-9376-5CE8DF7573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29780A-51C2-47E1-A2B0-59A592CB4A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B70191-7147-464E-8DD9-4D743A1C2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7CA0F1-EF9C-4012-B4A5-4A78CFBD1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12E55B-A8FD-4868-9418-8DF2930AB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588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512B90-57A1-48B9-BED4-BB68AC93FE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184795-F6C4-4F4E-9FFE-0AFBC4DF0E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F72839-00DD-459B-97BE-9E257A57C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C4D040-80EA-4D19-890C-32B01BB2E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851454-5402-458B-8A15-2A696D52A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188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A88107-AEAB-4FA4-9C7F-CADEEE38C1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746E2F-EDF9-450F-902B-047F122383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AACCEF-E240-48DC-9CA6-2F267EA06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B3BF5E-9C50-4EC5-A417-66E88DF1E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75EBC7-BA9E-42C0-A128-7D67E3D709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815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777E5-25FD-40B2-A140-3183B027AC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D58C-3AFE-4663-9EEB-4A8304D74C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748CAB-7E4C-431D-BC60-E6EC39BEED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47CDE7-A9FF-4E36-8022-672F4355C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C01D1A-E8F8-45A0-B692-F00BDC6A8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31958B-02E1-45DC-8061-B2129A91F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584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0B08CF-3A0C-4AD3-AB72-83CED0C23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5697C9-2A99-4188-9E13-CC56D68F12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F79E3D-53F9-4CDC-ADB1-69EC4AE2FC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81A2E5-590D-45A4-98A9-A77288B382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798BE9-C26C-4047-9E3F-E298164AC5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0594AA-38AE-47FF-88E4-DAE939BDD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5749A19-E9ED-4A7D-9276-0BDAA674B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23352D-ED2D-4BA7-BB41-EC68FB5790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555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0D1197-C32C-42A5-BA6D-B6EE4ADB03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F3C767-92F8-43F4-A9EC-6FA48DFD7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8594C3-9253-4AC5-881B-122BD9831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EE4AD0-8682-44DF-8015-C1964B356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823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F4A751-9F7F-4AAF-867E-53FF91D01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795965-9144-44AA-A662-FB83FD891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EBCC55-C23E-4C16-AE06-1BCA9CC4E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028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44DF6-CC2C-40C8-83F3-9F5B98C94D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51EF9C-8E7B-4BB7-BAE4-152E2C5929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C08292-2A2B-41B0-A0C6-07AFDFFAB3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0B39E5-9D8D-4F64-A199-5147108A5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983B02-E383-4C84-9612-CC5294C7E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1C778C-576A-47E1-B3EA-229EFCDDE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309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B0798-2A65-4AB8-B2C0-183D0F8F0E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A08A464-F520-46A8-97A0-53DD01ABFE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161EF2-DDCE-4313-BDCD-85E2F7E311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9F19B8-F89B-4BD6-BC6F-3AA8157F7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1F80C1-504F-4AFE-B664-33DBF8A37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7AF735-3441-43DD-9EB2-77F0CC993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06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1F49D8-1B5B-46AF-909F-A76E016984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478570-4CD4-40A6-8760-866CFCD1C1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538889-9AB1-47FF-B6F1-1A84466F13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232E5F-5303-486C-840B-742FC55DB5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1EA1B4-1E23-4E30-A1D6-618F80B01F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018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DF09B84-6803-4691-9543-74FDB59827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8208804"/>
              </p:ext>
            </p:extLst>
          </p:nvPr>
        </p:nvGraphicFramePr>
        <p:xfrm>
          <a:off x="2565538" y="89448"/>
          <a:ext cx="6323803" cy="6582024"/>
        </p:xfrm>
        <a:graphic>
          <a:graphicData uri="http://schemas.openxmlformats.org/drawingml/2006/table">
            <a:tbl>
              <a:tblPr/>
              <a:tblGrid>
                <a:gridCol w="1789429">
                  <a:extLst>
                    <a:ext uri="{9D8B030D-6E8A-4147-A177-3AD203B41FA5}">
                      <a16:colId xmlns:a16="http://schemas.microsoft.com/office/drawing/2014/main" val="1804186609"/>
                    </a:ext>
                  </a:extLst>
                </a:gridCol>
                <a:gridCol w="1511458">
                  <a:extLst>
                    <a:ext uri="{9D8B030D-6E8A-4147-A177-3AD203B41FA5}">
                      <a16:colId xmlns:a16="http://schemas.microsoft.com/office/drawing/2014/main" val="73946750"/>
                    </a:ext>
                  </a:extLst>
                </a:gridCol>
                <a:gridCol w="1511458">
                  <a:extLst>
                    <a:ext uri="{9D8B030D-6E8A-4147-A177-3AD203B41FA5}">
                      <a16:colId xmlns:a16="http://schemas.microsoft.com/office/drawing/2014/main" val="249114972"/>
                    </a:ext>
                  </a:extLst>
                </a:gridCol>
                <a:gridCol w="1511458">
                  <a:extLst>
                    <a:ext uri="{9D8B030D-6E8A-4147-A177-3AD203B41FA5}">
                      <a16:colId xmlns:a16="http://schemas.microsoft.com/office/drawing/2014/main" val="841330649"/>
                    </a:ext>
                  </a:extLst>
                </a:gridCol>
              </a:tblGrid>
              <a:tr h="393192">
                <a:tc gridSpan="4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PAFB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endParaRPr lang="en-US" sz="16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0324021"/>
                  </a:ext>
                </a:extLst>
              </a:tr>
              <a:tr h="39319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 value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2874866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8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5804015"/>
                  </a:ext>
                </a:extLst>
              </a:tr>
              <a:tr h="34859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der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0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026570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MI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2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1649172"/>
                  </a:ext>
                </a:extLst>
              </a:tr>
              <a:tr h="389075">
                <a:tc gridSpan="4">
                  <a:txBody>
                    <a:bodyPr/>
                    <a:lstStyle/>
                    <a:p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BC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1847571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 value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8146620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50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56418406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Gend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099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2313415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4701719"/>
                  </a:ext>
                </a:extLst>
              </a:tr>
              <a:tr h="389075">
                <a:tc gridSpan="4">
                  <a:txBody>
                    <a:bodyPr/>
                    <a:lstStyle/>
                    <a:p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bined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51369444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 value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1473667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5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7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01298159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Gend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3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0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44477441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BMI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1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62298645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e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4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3801817"/>
                  </a:ext>
                </a:extLst>
              </a:tr>
              <a:tr h="389075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ltiple linear regression model for urinary Cu level estimations. SE = standard error. *p&lt;0.05 is considered significant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661050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95115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7EB6BE4983DE444B2F113A7EEB2146E" ma:contentTypeVersion="14" ma:contentTypeDescription="Create a new document." ma:contentTypeScope="" ma:versionID="d2bbc4498918df55d425f67823786202">
  <xsd:schema xmlns:xsd="http://www.w3.org/2001/XMLSchema" xmlns:xs="http://www.w3.org/2001/XMLSchema" xmlns:p="http://schemas.microsoft.com/office/2006/metadata/properties" xmlns:ns3="66b0539c-6f40-4567-ada7-f2ec72548da0" xmlns:ns4="7dc2396f-f6a8-4665-9d28-9c0882c63bcd" targetNamespace="http://schemas.microsoft.com/office/2006/metadata/properties" ma:root="true" ma:fieldsID="f0645b73ebfcd1b17385658972074894" ns3:_="" ns4:_="">
    <xsd:import namespace="66b0539c-6f40-4567-ada7-f2ec72548da0"/>
    <xsd:import namespace="7dc2396f-f6a8-4665-9d28-9c0882c63bc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6b0539c-6f40-4567-ada7-f2ec72548da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dc2396f-f6a8-4665-9d28-9c0882c63bc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13DFBB4-9B0F-4288-898E-8D86974F00D3}">
  <ds:schemaRefs>
    <ds:schemaRef ds:uri="http://purl.org/dc/elements/1.1/"/>
    <ds:schemaRef ds:uri="http://schemas.microsoft.com/office/2006/metadata/properties"/>
    <ds:schemaRef ds:uri="66b0539c-6f40-4567-ada7-f2ec72548da0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7dc2396f-f6a8-4665-9d28-9c0882c63bcd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30023AC5-BF24-4CAE-8B07-244872EBA70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546912F-75A2-43C0-91CF-F1BDF8D7829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6b0539c-6f40-4567-ada7-f2ec72548da0"/>
    <ds:schemaRef ds:uri="7dc2396f-f6a8-4665-9d28-9c0882c63bc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89</Words>
  <Application>Microsoft Office PowerPoint</Application>
  <PresentationFormat>Widescreen</PresentationFormat>
  <Paragraphs>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Schwanekamp</dc:creator>
  <cp:lastModifiedBy>CHRISTIN DURAN</cp:lastModifiedBy>
  <cp:revision>7</cp:revision>
  <dcterms:created xsi:type="dcterms:W3CDTF">2022-03-24T14:05:01Z</dcterms:created>
  <dcterms:modified xsi:type="dcterms:W3CDTF">2022-03-24T20:51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7EB6BE4983DE444B2F113A7EEB2146E</vt:lpwstr>
  </property>
</Properties>
</file>